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806" autoAdjust="0"/>
  </p:normalViewPr>
  <p:slideViewPr>
    <p:cSldViewPr>
      <p:cViewPr varScale="1">
        <p:scale>
          <a:sx n="46" d="100"/>
          <a:sy n="46" d="100"/>
        </p:scale>
        <p:origin x="2112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07112" y="1339428"/>
            <a:ext cx="3005864" cy="1970863"/>
            <a:chOff x="207112" y="7137641"/>
            <a:chExt cx="3005864" cy="1970863"/>
          </a:xfrm>
        </p:grpSpPr>
        <p:pic>
          <p:nvPicPr>
            <p:cNvPr id="3" name="Picture 2" descr="C:\Users\ImageQuant\Desktop\Sonomi\Fstl1\F27 Time course FB\Fstl1 12% Biorad timecourse 20130601_1845_6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7112" y="7137641"/>
              <a:ext cx="3005864" cy="197086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正方形/長方形 22"/>
            <p:cNvSpPr/>
            <p:nvPr/>
          </p:nvSpPr>
          <p:spPr>
            <a:xfrm>
              <a:off x="980727" y="7863205"/>
              <a:ext cx="1440161" cy="22165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テキスト ボックス 23"/>
            <p:cNvSpPr txBox="1"/>
            <p:nvPr/>
          </p:nvSpPr>
          <p:spPr>
            <a:xfrm>
              <a:off x="890171" y="7596336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stl1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テキスト ボックス 1"/>
          <p:cNvSpPr txBox="1"/>
          <p:nvPr/>
        </p:nvSpPr>
        <p:spPr>
          <a:xfrm>
            <a:off x="163716" y="1294067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3284984" y="1259632"/>
            <a:ext cx="3184001" cy="2122667"/>
            <a:chOff x="3284984" y="7057845"/>
            <a:chExt cx="3184001" cy="2122667"/>
          </a:xfrm>
        </p:grpSpPr>
        <p:pic>
          <p:nvPicPr>
            <p:cNvPr id="8" name="Picture 8" descr="C:\Users\ImageQuant\Desktop\Sonomi\Fstl1\F27 Time course FB\tubulin\tubulin 20141021_1139_1_1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84984" y="7057845"/>
              <a:ext cx="3184001" cy="212266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正方形/長方形 22"/>
            <p:cNvSpPr/>
            <p:nvPr/>
          </p:nvSpPr>
          <p:spPr>
            <a:xfrm>
              <a:off x="4071959" y="7725199"/>
              <a:ext cx="1440161" cy="22165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テキスト ボックス 23"/>
            <p:cNvSpPr txBox="1"/>
            <p:nvPr/>
          </p:nvSpPr>
          <p:spPr>
            <a:xfrm>
              <a:off x="3993248" y="7443472"/>
              <a:ext cx="7963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5800005"/>
              </p:ext>
            </p:extLst>
          </p:nvPr>
        </p:nvGraphicFramePr>
        <p:xfrm>
          <a:off x="207112" y="4427984"/>
          <a:ext cx="6261875" cy="208823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82500"/>
                <a:gridCol w="582500"/>
                <a:gridCol w="728125"/>
                <a:gridCol w="728125"/>
                <a:gridCol w="728125"/>
                <a:gridCol w="728125"/>
                <a:gridCol w="728125"/>
                <a:gridCol w="728125"/>
                <a:gridCol w="728125"/>
              </a:tblGrid>
              <a:tr h="279866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igure 6C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8338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lative transcript level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833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Fstl1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o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784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0396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247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7019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10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0884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833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rTGFb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8669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6599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51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14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040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1146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833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S100A4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o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26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009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90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68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0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0874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833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rTGFb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1322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277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076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055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209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104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833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Acta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o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747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252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176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833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rTGFb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9445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839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820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15876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</TotalTime>
  <Words>48</Words>
  <Application>Microsoft Office PowerPoint</Application>
  <PresentationFormat>On-screen Show (4:3)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nomi</dc:creator>
  <cp:lastModifiedBy>Whittaker, Linda D</cp:lastModifiedBy>
  <cp:revision>88</cp:revision>
  <dcterms:modified xsi:type="dcterms:W3CDTF">2016-04-22T18:40:12Z</dcterms:modified>
</cp:coreProperties>
</file>